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2431" autoAdjust="0"/>
    <p:restoredTop sz="56306"/>
  </p:normalViewPr>
  <p:slideViewPr>
    <p:cSldViewPr snapToGrid="0">
      <p:cViewPr>
        <p:scale>
          <a:sx n="102" d="100"/>
          <a:sy n="102" d="100"/>
        </p:scale>
        <p:origin x="1760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IT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3BCFA5-8D94-154B-8131-9F82A1799930}" type="datetimeFigureOut">
              <a:rPr lang="es-IT" smtClean="0"/>
              <a:t>26/02/25</a:t>
            </a:fld>
            <a:endParaRPr lang="es-IT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IT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IT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IT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954A832-B7B8-B843-BF28-1B710E4AA454}" type="slidenum">
              <a:rPr lang="es-IT" smtClean="0"/>
              <a:t>‹Nº›</a:t>
            </a:fld>
            <a:endParaRPr lang="es-IT"/>
          </a:p>
        </p:txBody>
      </p:sp>
    </p:spTree>
    <p:extLst>
      <p:ext uri="{BB962C8B-B14F-4D97-AF65-F5344CB8AC3E}">
        <p14:creationId xmlns:p14="http://schemas.microsoft.com/office/powerpoint/2010/main" val="20264041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>
              <a:lnSpc>
                <a:spcPct val="200000"/>
              </a:lnSpc>
            </a:pPr>
            <a:r>
              <a:rPr lang="en-GB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1. Flow chart of participants </a:t>
            </a:r>
            <a:r>
              <a:rPr lang="en-GB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rom the ‘</a:t>
            </a:r>
            <a:r>
              <a:rPr lang="en-GB" sz="1800" b="1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aldecilla</a:t>
            </a:r>
            <a:r>
              <a:rPr lang="en-GB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ohort for the Study of Memory and Brain Aging’. </a:t>
            </a:r>
            <a:endParaRPr lang="es-IT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r>
              <a:rPr lang="en-GB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bbreviations: MRI, magnetic resonance imaging. MMSE: mini-mental state examination.</a:t>
            </a:r>
            <a:endParaRPr lang="es-IT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s-IT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954A832-B7B8-B843-BF28-1B710E4AA454}" type="slidenum">
              <a:rPr lang="es-IT" smtClean="0"/>
              <a:t>1</a:t>
            </a:fld>
            <a:endParaRPr lang="es-IT"/>
          </a:p>
        </p:txBody>
      </p:sp>
    </p:spTree>
    <p:extLst>
      <p:ext uri="{BB962C8B-B14F-4D97-AF65-F5344CB8AC3E}">
        <p14:creationId xmlns:p14="http://schemas.microsoft.com/office/powerpoint/2010/main" val="96996313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C320D-38D6-4FD1-A6E1-7467BAC620C1}" type="datetimeFigureOut">
              <a:rPr lang="es-ES" smtClean="0"/>
              <a:t>26/2/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956327-AE98-493B-885B-59BDF78B209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369577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C320D-38D6-4FD1-A6E1-7467BAC620C1}" type="datetimeFigureOut">
              <a:rPr lang="es-ES" smtClean="0"/>
              <a:t>26/2/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956327-AE98-493B-885B-59BDF78B209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466902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C320D-38D6-4FD1-A6E1-7467BAC620C1}" type="datetimeFigureOut">
              <a:rPr lang="es-ES" smtClean="0"/>
              <a:t>26/2/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956327-AE98-493B-885B-59BDF78B209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6421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C320D-38D6-4FD1-A6E1-7467BAC620C1}" type="datetimeFigureOut">
              <a:rPr lang="es-ES" smtClean="0"/>
              <a:t>26/2/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956327-AE98-493B-885B-59BDF78B209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124359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C320D-38D6-4FD1-A6E1-7467BAC620C1}" type="datetimeFigureOut">
              <a:rPr lang="es-ES" smtClean="0"/>
              <a:t>26/2/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956327-AE98-493B-885B-59BDF78B209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66740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C320D-38D6-4FD1-A6E1-7467BAC620C1}" type="datetimeFigureOut">
              <a:rPr lang="es-ES" smtClean="0"/>
              <a:t>26/2/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956327-AE98-493B-885B-59BDF78B209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95877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C320D-38D6-4FD1-A6E1-7467BAC620C1}" type="datetimeFigureOut">
              <a:rPr lang="es-ES" smtClean="0"/>
              <a:t>26/2/25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956327-AE98-493B-885B-59BDF78B209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6482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C320D-38D6-4FD1-A6E1-7467BAC620C1}" type="datetimeFigureOut">
              <a:rPr lang="es-ES" smtClean="0"/>
              <a:t>26/2/25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956327-AE98-493B-885B-59BDF78B209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594079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C320D-38D6-4FD1-A6E1-7467BAC620C1}" type="datetimeFigureOut">
              <a:rPr lang="es-ES" smtClean="0"/>
              <a:t>26/2/25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956327-AE98-493B-885B-59BDF78B209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161624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C320D-38D6-4FD1-A6E1-7467BAC620C1}" type="datetimeFigureOut">
              <a:rPr lang="es-ES" smtClean="0"/>
              <a:t>26/2/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956327-AE98-493B-885B-59BDF78B209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156914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CC320D-38D6-4FD1-A6E1-7467BAC620C1}" type="datetimeFigureOut">
              <a:rPr lang="es-ES" smtClean="0"/>
              <a:t>26/2/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956327-AE98-493B-885B-59BDF78B209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707347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CC320D-38D6-4FD1-A6E1-7467BAC620C1}" type="datetimeFigureOut">
              <a:rPr lang="es-ES" smtClean="0"/>
              <a:t>26/2/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956327-AE98-493B-885B-59BDF78B209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885375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lumMod val="95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echa: a la izquierda, derecha y arriba 4">
            <a:extLst>
              <a:ext uri="{FF2B5EF4-FFF2-40B4-BE49-F238E27FC236}">
                <a16:creationId xmlns:a16="http://schemas.microsoft.com/office/drawing/2014/main" id="{50CA0234-8890-9656-5B67-A038281D75B1}"/>
              </a:ext>
            </a:extLst>
          </p:cNvPr>
          <p:cNvSpPr/>
          <p:nvPr/>
        </p:nvSpPr>
        <p:spPr>
          <a:xfrm rot="5400000">
            <a:off x="2637843" y="1716199"/>
            <a:ext cx="820616" cy="1266094"/>
          </a:xfrm>
          <a:prstGeom prst="leftRightUp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 anchorCtr="1"/>
          <a:lstStyle/>
          <a:p>
            <a:pPr algn="ctr"/>
            <a:endParaRPr lang="es-E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tángulo 5">
            <a:extLst>
              <a:ext uri="{FF2B5EF4-FFF2-40B4-BE49-F238E27FC236}">
                <a16:creationId xmlns:a16="http://schemas.microsoft.com/office/drawing/2014/main" id="{86120314-B265-EC4E-FE19-BBAAC5B6A40A}"/>
              </a:ext>
            </a:extLst>
          </p:cNvPr>
          <p:cNvSpPr/>
          <p:nvPr/>
        </p:nvSpPr>
        <p:spPr>
          <a:xfrm>
            <a:off x="3707213" y="2025762"/>
            <a:ext cx="1266093" cy="656493"/>
          </a:xfrm>
          <a:prstGeom prst="rect">
            <a:avLst/>
          </a:prstGeom>
          <a:ln w="19050"/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rtlCol="0" anchor="ctr" anchorCtr="1"/>
          <a:lstStyle/>
          <a:p>
            <a:pPr algn="ctr"/>
            <a:endParaRPr lang="es-E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Rectángulo 6">
            <a:extLst>
              <a:ext uri="{FF2B5EF4-FFF2-40B4-BE49-F238E27FC236}">
                <a16:creationId xmlns:a16="http://schemas.microsoft.com/office/drawing/2014/main" id="{01CC97C5-1F08-C9DE-2063-AA3F94D48B8C}"/>
              </a:ext>
            </a:extLst>
          </p:cNvPr>
          <p:cNvSpPr/>
          <p:nvPr/>
        </p:nvSpPr>
        <p:spPr>
          <a:xfrm>
            <a:off x="1990505" y="2789667"/>
            <a:ext cx="1266093" cy="656493"/>
          </a:xfrm>
          <a:prstGeom prst="rect">
            <a:avLst/>
          </a:prstGeom>
          <a:ln w="19050"/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 anchorCtr="1"/>
          <a:lstStyle/>
          <a:p>
            <a:pPr algn="ctr"/>
            <a:endParaRPr lang="es-E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Flecha: a la izquierda, derecha y arriba 7">
            <a:extLst>
              <a:ext uri="{FF2B5EF4-FFF2-40B4-BE49-F238E27FC236}">
                <a16:creationId xmlns:a16="http://schemas.microsoft.com/office/drawing/2014/main" id="{B6476CE4-7F8F-17DC-78F6-CD1F52D6DE1C}"/>
              </a:ext>
            </a:extLst>
          </p:cNvPr>
          <p:cNvSpPr/>
          <p:nvPr/>
        </p:nvSpPr>
        <p:spPr>
          <a:xfrm rot="5400000">
            <a:off x="2644435" y="3242028"/>
            <a:ext cx="820616" cy="1266094"/>
          </a:xfrm>
          <a:prstGeom prst="leftRightUp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 anchorCtr="1"/>
          <a:lstStyle/>
          <a:p>
            <a:pPr algn="ctr"/>
            <a:endParaRPr lang="es-E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Rectángulo 8">
            <a:extLst>
              <a:ext uri="{FF2B5EF4-FFF2-40B4-BE49-F238E27FC236}">
                <a16:creationId xmlns:a16="http://schemas.microsoft.com/office/drawing/2014/main" id="{BD8D54BA-D558-7E17-855A-4B9CEB3E8301}"/>
              </a:ext>
            </a:extLst>
          </p:cNvPr>
          <p:cNvSpPr/>
          <p:nvPr/>
        </p:nvSpPr>
        <p:spPr>
          <a:xfrm>
            <a:off x="3744567" y="3574745"/>
            <a:ext cx="1266093" cy="65649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 anchorCtr="1"/>
          <a:lstStyle/>
          <a:p>
            <a:pPr algn="ctr"/>
            <a:endParaRPr lang="es-E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Rectángulo 9">
            <a:extLst>
              <a:ext uri="{FF2B5EF4-FFF2-40B4-BE49-F238E27FC236}">
                <a16:creationId xmlns:a16="http://schemas.microsoft.com/office/drawing/2014/main" id="{D1C5B56A-EEF3-C842-D7E2-9C4E99193601}"/>
              </a:ext>
            </a:extLst>
          </p:cNvPr>
          <p:cNvSpPr/>
          <p:nvPr/>
        </p:nvSpPr>
        <p:spPr>
          <a:xfrm>
            <a:off x="1996725" y="4314398"/>
            <a:ext cx="1266093" cy="656493"/>
          </a:xfrm>
          <a:prstGeom prst="rect">
            <a:avLst/>
          </a:prstGeom>
          <a:ln w="19050"/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 anchorCtr="1"/>
          <a:lstStyle/>
          <a:p>
            <a:pPr algn="ctr"/>
            <a:endParaRPr lang="es-E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Flecha: a la izquierda, derecha y arriba 10">
            <a:extLst>
              <a:ext uri="{FF2B5EF4-FFF2-40B4-BE49-F238E27FC236}">
                <a16:creationId xmlns:a16="http://schemas.microsoft.com/office/drawing/2014/main" id="{37E73B70-E624-DEB3-394D-426042DBFD1C}"/>
              </a:ext>
            </a:extLst>
          </p:cNvPr>
          <p:cNvSpPr/>
          <p:nvPr/>
        </p:nvSpPr>
        <p:spPr>
          <a:xfrm rot="5400000">
            <a:off x="2637843" y="4761932"/>
            <a:ext cx="820616" cy="1266094"/>
          </a:xfrm>
          <a:prstGeom prst="leftRightUp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 anchorCtr="1"/>
          <a:lstStyle/>
          <a:p>
            <a:pPr algn="ctr"/>
            <a:endParaRPr lang="es-E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Flecha: a la izquierda, derecha y arriba 13">
            <a:extLst>
              <a:ext uri="{FF2B5EF4-FFF2-40B4-BE49-F238E27FC236}">
                <a16:creationId xmlns:a16="http://schemas.microsoft.com/office/drawing/2014/main" id="{8CEE6997-ABE5-EB09-DA4D-9A71EF8E5C35}"/>
              </a:ext>
            </a:extLst>
          </p:cNvPr>
          <p:cNvSpPr/>
          <p:nvPr/>
        </p:nvSpPr>
        <p:spPr>
          <a:xfrm rot="5400000">
            <a:off x="2605962" y="6349755"/>
            <a:ext cx="820616" cy="1266094"/>
          </a:xfrm>
          <a:prstGeom prst="leftRightUp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 anchorCtr="1"/>
          <a:lstStyle/>
          <a:p>
            <a:pPr algn="ctr"/>
            <a:endParaRPr lang="es-E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Rectángulo 14">
            <a:extLst>
              <a:ext uri="{FF2B5EF4-FFF2-40B4-BE49-F238E27FC236}">
                <a16:creationId xmlns:a16="http://schemas.microsoft.com/office/drawing/2014/main" id="{FE5F72E2-934F-3958-7DCF-E8639C24F574}"/>
              </a:ext>
            </a:extLst>
          </p:cNvPr>
          <p:cNvSpPr/>
          <p:nvPr/>
        </p:nvSpPr>
        <p:spPr>
          <a:xfrm>
            <a:off x="3770585" y="6620923"/>
            <a:ext cx="1266093" cy="65649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 anchorCtr="1"/>
          <a:lstStyle/>
          <a:p>
            <a:pPr algn="ctr"/>
            <a:endParaRPr lang="es-E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Rectángulo 15">
            <a:extLst>
              <a:ext uri="{FF2B5EF4-FFF2-40B4-BE49-F238E27FC236}">
                <a16:creationId xmlns:a16="http://schemas.microsoft.com/office/drawing/2014/main" id="{9D986E79-A081-ED09-373C-B2B18A52C643}"/>
              </a:ext>
            </a:extLst>
          </p:cNvPr>
          <p:cNvSpPr/>
          <p:nvPr/>
        </p:nvSpPr>
        <p:spPr>
          <a:xfrm>
            <a:off x="1958634" y="7409589"/>
            <a:ext cx="1266093" cy="656493"/>
          </a:xfrm>
          <a:prstGeom prst="rect">
            <a:avLst/>
          </a:prstGeom>
          <a:ln w="19050"/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 anchorCtr="1"/>
          <a:lstStyle/>
          <a:p>
            <a:pPr algn="ctr"/>
            <a:endParaRPr lang="es-E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Flecha: a la izquierda, derecha y arriba 16">
            <a:extLst>
              <a:ext uri="{FF2B5EF4-FFF2-40B4-BE49-F238E27FC236}">
                <a16:creationId xmlns:a16="http://schemas.microsoft.com/office/drawing/2014/main" id="{DB4007CE-AEE6-E2DE-85C8-714B77ECC15F}"/>
              </a:ext>
            </a:extLst>
          </p:cNvPr>
          <p:cNvSpPr/>
          <p:nvPr/>
        </p:nvSpPr>
        <p:spPr>
          <a:xfrm rot="5400000">
            <a:off x="2601207" y="7857638"/>
            <a:ext cx="820616" cy="1266094"/>
          </a:xfrm>
          <a:prstGeom prst="leftRightUp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 anchorCtr="1"/>
          <a:lstStyle/>
          <a:p>
            <a:pPr algn="ctr"/>
            <a:endParaRPr lang="es-E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Rectángulo 17">
            <a:extLst>
              <a:ext uri="{FF2B5EF4-FFF2-40B4-BE49-F238E27FC236}">
                <a16:creationId xmlns:a16="http://schemas.microsoft.com/office/drawing/2014/main" id="{4B39A4E4-A175-5F4F-386F-9212D2096383}"/>
              </a:ext>
            </a:extLst>
          </p:cNvPr>
          <p:cNvSpPr/>
          <p:nvPr/>
        </p:nvSpPr>
        <p:spPr>
          <a:xfrm>
            <a:off x="3677531" y="8162070"/>
            <a:ext cx="1266093" cy="656493"/>
          </a:xfrm>
          <a:prstGeom prst="rect">
            <a:avLst/>
          </a:prstGeom>
          <a:ln w="19050"/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rtlCol="0" anchor="ctr" anchorCtr="1"/>
          <a:lstStyle/>
          <a:p>
            <a:pPr algn="ctr"/>
            <a:endParaRPr lang="es-E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Rectángulo 18">
            <a:extLst>
              <a:ext uri="{FF2B5EF4-FFF2-40B4-BE49-F238E27FC236}">
                <a16:creationId xmlns:a16="http://schemas.microsoft.com/office/drawing/2014/main" id="{EA7B165C-0202-3C04-35B2-51D42E9ACCB4}"/>
              </a:ext>
            </a:extLst>
          </p:cNvPr>
          <p:cNvSpPr/>
          <p:nvPr/>
        </p:nvSpPr>
        <p:spPr>
          <a:xfrm>
            <a:off x="1958625" y="8924069"/>
            <a:ext cx="1266093" cy="656493"/>
          </a:xfrm>
          <a:prstGeom prst="rect">
            <a:avLst/>
          </a:prstGeom>
          <a:ln w="19050"/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 anchorCtr="1"/>
          <a:lstStyle/>
          <a:p>
            <a:pPr algn="ctr"/>
            <a:endParaRPr lang="es-E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Flecha: a la izquierda, derecha y arriba 19">
            <a:extLst>
              <a:ext uri="{FF2B5EF4-FFF2-40B4-BE49-F238E27FC236}">
                <a16:creationId xmlns:a16="http://schemas.microsoft.com/office/drawing/2014/main" id="{657095A8-C3CD-7959-2EE0-B973AC22AF4E}"/>
              </a:ext>
            </a:extLst>
          </p:cNvPr>
          <p:cNvSpPr/>
          <p:nvPr/>
        </p:nvSpPr>
        <p:spPr>
          <a:xfrm rot="5400000">
            <a:off x="2599008" y="9369182"/>
            <a:ext cx="820616" cy="1266094"/>
          </a:xfrm>
          <a:prstGeom prst="leftRightUp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 anchorCtr="1"/>
          <a:lstStyle/>
          <a:p>
            <a:pPr algn="ctr"/>
            <a:endParaRPr lang="es-E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Rectángulo 21">
            <a:extLst>
              <a:ext uri="{FF2B5EF4-FFF2-40B4-BE49-F238E27FC236}">
                <a16:creationId xmlns:a16="http://schemas.microsoft.com/office/drawing/2014/main" id="{BB1A24DD-3188-37FD-FD1B-D4BE2DE8C94B}"/>
              </a:ext>
            </a:extLst>
          </p:cNvPr>
          <p:cNvSpPr/>
          <p:nvPr/>
        </p:nvSpPr>
        <p:spPr>
          <a:xfrm>
            <a:off x="1956798" y="10443813"/>
            <a:ext cx="1266093" cy="656493"/>
          </a:xfrm>
          <a:prstGeom prst="rect">
            <a:avLst/>
          </a:prstGeom>
          <a:ln w="19050"/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 anchorCtr="1"/>
          <a:lstStyle/>
          <a:p>
            <a:pPr algn="ctr"/>
            <a:endParaRPr lang="es-E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B52F9454-3454-A1BB-A0A8-CDF4F8184B9B}"/>
              </a:ext>
            </a:extLst>
          </p:cNvPr>
          <p:cNvSpPr txBox="1"/>
          <p:nvPr/>
        </p:nvSpPr>
        <p:spPr>
          <a:xfrm>
            <a:off x="1999663" y="1183525"/>
            <a:ext cx="1242650" cy="738664"/>
          </a:xfrm>
          <a:prstGeom prst="rect">
            <a:avLst/>
          </a:prstGeom>
          <a:ln w="19050"/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 anchor="ctr" anchorCtr="1">
            <a:spAutoFit/>
          </a:bodyPr>
          <a:lstStyle/>
          <a:p>
            <a:pPr algn="ctr"/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pen </a:t>
            </a:r>
            <a:r>
              <a:rPr lang="es-E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ll</a:t>
            </a:r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s-E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ocal media </a:t>
            </a:r>
          </a:p>
          <a:p>
            <a:pPr algn="ctr"/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&gt;55 </a:t>
            </a:r>
            <a:r>
              <a:rPr lang="es-E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ears</a:t>
            </a:r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  <a:p>
            <a:pPr algn="ctr"/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328</a:t>
            </a:r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E0052D76-872B-09D8-561A-F604128D6E60}"/>
              </a:ext>
            </a:extLst>
          </p:cNvPr>
          <p:cNvSpPr txBox="1"/>
          <p:nvPr/>
        </p:nvSpPr>
        <p:spPr>
          <a:xfrm>
            <a:off x="3716367" y="2141496"/>
            <a:ext cx="1242650" cy="415498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algn="ctr"/>
            <a:r>
              <a:rPr lang="es-E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nding</a:t>
            </a:r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valuation</a:t>
            </a:r>
            <a:endParaRPr lang="es-E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60</a:t>
            </a: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CC98A295-35C4-6CA4-D3B2-A5456190F138}"/>
              </a:ext>
            </a:extLst>
          </p:cNvPr>
          <p:cNvSpPr txBox="1"/>
          <p:nvPr/>
        </p:nvSpPr>
        <p:spPr>
          <a:xfrm>
            <a:off x="2016514" y="2846260"/>
            <a:ext cx="1289537" cy="577081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algn="ctr"/>
            <a:r>
              <a:rPr lang="es-E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itial</a:t>
            </a:r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uestionnaire</a:t>
            </a:r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s-E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vailavility</a:t>
            </a:r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  <a:p>
            <a:pPr algn="ctr"/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268</a:t>
            </a:r>
          </a:p>
        </p:txBody>
      </p:sp>
      <p:sp>
        <p:nvSpPr>
          <p:cNvPr id="28" name="CuadroTexto 27">
            <a:extLst>
              <a:ext uri="{FF2B5EF4-FFF2-40B4-BE49-F238E27FC236}">
                <a16:creationId xmlns:a16="http://schemas.microsoft.com/office/drawing/2014/main" id="{A3D15F4A-220F-BEF2-E64F-024E355A932B}"/>
              </a:ext>
            </a:extLst>
          </p:cNvPr>
          <p:cNvSpPr txBox="1"/>
          <p:nvPr/>
        </p:nvSpPr>
        <p:spPr>
          <a:xfrm>
            <a:off x="3720748" y="3509297"/>
            <a:ext cx="1289537" cy="738664"/>
          </a:xfrm>
          <a:prstGeom prst="rect">
            <a:avLst/>
          </a:prstGeom>
          <a:ln w="19050"/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 anchor="ctr" anchorCtr="1">
            <a:spAutoFit/>
          </a:bodyPr>
          <a:lstStyle/>
          <a:p>
            <a:pPr algn="ctr"/>
            <a:r>
              <a:rPr lang="es-E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ot</a:t>
            </a:r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vailable</a:t>
            </a:r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es-E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hedules</a:t>
            </a:r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s-E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nges</a:t>
            </a:r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y</a:t>
            </a:r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…)</a:t>
            </a:r>
          </a:p>
          <a:p>
            <a:pPr algn="ctr"/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26</a:t>
            </a:r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041DD68C-5121-0D00-A816-D5892DEE2CC9}"/>
              </a:ext>
            </a:extLst>
          </p:cNvPr>
          <p:cNvSpPr txBox="1"/>
          <p:nvPr/>
        </p:nvSpPr>
        <p:spPr>
          <a:xfrm>
            <a:off x="1985002" y="4365205"/>
            <a:ext cx="1289537" cy="577081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algn="ctr"/>
            <a:r>
              <a:rPr lang="es-E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vailable</a:t>
            </a:r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50">
                <a:latin typeface="Times New Roman" panose="02020603050405020304" pitchFamily="18" charset="0"/>
                <a:cs typeface="Times New Roman" panose="02020603050405020304" pitchFamily="18" charset="0"/>
              </a:rPr>
              <a:t>participants</a:t>
            </a:r>
            <a:endParaRPr lang="es-E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242</a:t>
            </a:r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9D453747-D56F-2677-8AB4-32A838BF51DE}"/>
              </a:ext>
            </a:extLst>
          </p:cNvPr>
          <p:cNvSpPr txBox="1"/>
          <p:nvPr/>
        </p:nvSpPr>
        <p:spPr>
          <a:xfrm>
            <a:off x="3713433" y="5031786"/>
            <a:ext cx="1289537" cy="738664"/>
          </a:xfrm>
          <a:prstGeom prst="rect">
            <a:avLst/>
          </a:prstGeom>
          <a:ln w="19050"/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 anchor="ctr" anchorCtr="1">
            <a:spAutoFit/>
          </a:bodyPr>
          <a:lstStyle/>
          <a:p>
            <a:pPr algn="ctr"/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umbar </a:t>
            </a:r>
            <a:r>
              <a:rPr lang="es-E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uncture</a:t>
            </a:r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raindication</a:t>
            </a:r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/ MRI </a:t>
            </a:r>
            <a:r>
              <a:rPr lang="es-E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tolerance</a:t>
            </a:r>
            <a:endParaRPr lang="es-E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13</a:t>
            </a:r>
          </a:p>
        </p:txBody>
      </p:sp>
      <p:sp>
        <p:nvSpPr>
          <p:cNvPr id="31" name="CuadroTexto 30">
            <a:extLst>
              <a:ext uri="{FF2B5EF4-FFF2-40B4-BE49-F238E27FC236}">
                <a16:creationId xmlns:a16="http://schemas.microsoft.com/office/drawing/2014/main" id="{A38AD0F4-65F9-C364-A6EA-5F43B97262CA}"/>
              </a:ext>
            </a:extLst>
          </p:cNvPr>
          <p:cNvSpPr txBox="1"/>
          <p:nvPr/>
        </p:nvSpPr>
        <p:spPr>
          <a:xfrm>
            <a:off x="1946170" y="5820006"/>
            <a:ext cx="1348148" cy="738664"/>
          </a:xfrm>
          <a:prstGeom prst="rect">
            <a:avLst/>
          </a:prstGeom>
          <a:ln w="19050"/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 anchor="ctr" anchorCtr="1">
            <a:spAutoFit/>
          </a:bodyPr>
          <a:lstStyle/>
          <a:p>
            <a:pPr algn="ctr"/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</a:t>
            </a:r>
            <a:r>
              <a:rPr lang="es-E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ntraindications</a:t>
            </a:r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plementary</a:t>
            </a:r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sts</a:t>
            </a:r>
            <a:endParaRPr lang="es-E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229</a:t>
            </a:r>
          </a:p>
        </p:txBody>
      </p:sp>
      <p:sp>
        <p:nvSpPr>
          <p:cNvPr id="32" name="CuadroTexto 31">
            <a:extLst>
              <a:ext uri="{FF2B5EF4-FFF2-40B4-BE49-F238E27FC236}">
                <a16:creationId xmlns:a16="http://schemas.microsoft.com/office/drawing/2014/main" id="{49CF1A83-BA60-AE06-4787-D624FDE158A6}"/>
              </a:ext>
            </a:extLst>
          </p:cNvPr>
          <p:cNvSpPr txBox="1"/>
          <p:nvPr/>
        </p:nvSpPr>
        <p:spPr>
          <a:xfrm>
            <a:off x="3677897" y="6616743"/>
            <a:ext cx="1489551" cy="738664"/>
          </a:xfrm>
          <a:prstGeom prst="rect">
            <a:avLst/>
          </a:prstGeom>
          <a:ln w="19050"/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 anchor="ctr" anchorCtr="1">
            <a:spAutoFit/>
          </a:bodyPr>
          <a:lstStyle/>
          <a:p>
            <a:pPr algn="ctr"/>
            <a:r>
              <a:rPr lang="es-E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jor</a:t>
            </a:r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ctr"/>
            <a:r>
              <a:rPr lang="es-E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ystemic</a:t>
            </a:r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/</a:t>
            </a:r>
            <a:r>
              <a:rPr lang="es-E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sychiatric</a:t>
            </a:r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ctr"/>
            <a:r>
              <a:rPr lang="es-E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thology</a:t>
            </a:r>
            <a:endParaRPr lang="es-E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8</a:t>
            </a:r>
          </a:p>
        </p:txBody>
      </p:sp>
      <p:sp>
        <p:nvSpPr>
          <p:cNvPr id="33" name="CuadroTexto 32">
            <a:extLst>
              <a:ext uri="{FF2B5EF4-FFF2-40B4-BE49-F238E27FC236}">
                <a16:creationId xmlns:a16="http://schemas.microsoft.com/office/drawing/2014/main" id="{04A75917-2A71-EE10-5659-335F606C5BBD}"/>
              </a:ext>
            </a:extLst>
          </p:cNvPr>
          <p:cNvSpPr txBox="1"/>
          <p:nvPr/>
        </p:nvSpPr>
        <p:spPr>
          <a:xfrm>
            <a:off x="1946170" y="7534646"/>
            <a:ext cx="1289537" cy="415498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algn="ctr"/>
            <a:r>
              <a:rPr lang="es-E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ealthy</a:t>
            </a:r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bjects</a:t>
            </a:r>
            <a:endParaRPr lang="es-E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221</a:t>
            </a:r>
          </a:p>
        </p:txBody>
      </p:sp>
      <p:sp>
        <p:nvSpPr>
          <p:cNvPr id="34" name="CuadroTexto 33">
            <a:extLst>
              <a:ext uri="{FF2B5EF4-FFF2-40B4-BE49-F238E27FC236}">
                <a16:creationId xmlns:a16="http://schemas.microsoft.com/office/drawing/2014/main" id="{0CAFBDB6-866D-AB44-CDF3-9176F7B80C68}"/>
              </a:ext>
            </a:extLst>
          </p:cNvPr>
          <p:cNvSpPr txBox="1"/>
          <p:nvPr/>
        </p:nvSpPr>
        <p:spPr>
          <a:xfrm>
            <a:off x="3608667" y="8195555"/>
            <a:ext cx="1359876" cy="577081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algn="ctr"/>
            <a:r>
              <a:rPr lang="es-E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jor</a:t>
            </a:r>
            <a:endParaRPr lang="es-E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oke</a:t>
            </a:r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/ </a:t>
            </a:r>
            <a:r>
              <a:rPr lang="es-E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rain</a:t>
            </a:r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umor</a:t>
            </a:r>
          </a:p>
          <a:p>
            <a:pPr algn="ctr"/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3</a:t>
            </a:r>
          </a:p>
        </p:txBody>
      </p:sp>
      <p:sp>
        <p:nvSpPr>
          <p:cNvPr id="35" name="CuadroTexto 34">
            <a:extLst>
              <a:ext uri="{FF2B5EF4-FFF2-40B4-BE49-F238E27FC236}">
                <a16:creationId xmlns:a16="http://schemas.microsoft.com/office/drawing/2014/main" id="{B822B641-38E7-ABD1-0BB5-E11CDB7F48D8}"/>
              </a:ext>
            </a:extLst>
          </p:cNvPr>
          <p:cNvSpPr txBox="1"/>
          <p:nvPr/>
        </p:nvSpPr>
        <p:spPr>
          <a:xfrm>
            <a:off x="1935181" y="8955884"/>
            <a:ext cx="1289537" cy="577081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algn="ctr"/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</a:t>
            </a:r>
            <a:r>
              <a:rPr lang="es-E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jor</a:t>
            </a:r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ndings</a:t>
            </a:r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n</a:t>
            </a:r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RI</a:t>
            </a:r>
          </a:p>
          <a:p>
            <a:pPr algn="ctr"/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218</a:t>
            </a:r>
          </a:p>
        </p:txBody>
      </p:sp>
      <p:sp>
        <p:nvSpPr>
          <p:cNvPr id="36" name="CuadroTexto 35">
            <a:extLst>
              <a:ext uri="{FF2B5EF4-FFF2-40B4-BE49-F238E27FC236}">
                <a16:creationId xmlns:a16="http://schemas.microsoft.com/office/drawing/2014/main" id="{E1B101D7-FB81-C6C6-D7D9-B10C76B9E081}"/>
              </a:ext>
            </a:extLst>
          </p:cNvPr>
          <p:cNvSpPr txBox="1"/>
          <p:nvPr/>
        </p:nvSpPr>
        <p:spPr>
          <a:xfrm>
            <a:off x="3680093" y="9635463"/>
            <a:ext cx="1289537" cy="738664"/>
          </a:xfrm>
          <a:prstGeom prst="rect">
            <a:avLst/>
          </a:prstGeom>
          <a:ln w="19050"/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wrap="square" rtlCol="0" anchor="ctr" anchorCtr="1">
            <a:spAutoFit/>
          </a:bodyPr>
          <a:lstStyle/>
          <a:p>
            <a:pPr algn="ctr"/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R </a:t>
            </a:r>
            <a:r>
              <a:rPr lang="es-E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cale</a:t>
            </a:r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gt;0 </a:t>
            </a:r>
            <a:r>
              <a:rPr lang="es-E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</a:t>
            </a:r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normal</a:t>
            </a:r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MSE </a:t>
            </a:r>
            <a:r>
              <a:rPr lang="es-E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sults</a:t>
            </a:r>
            <a:endParaRPr lang="es-E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=7</a:t>
            </a:r>
          </a:p>
        </p:txBody>
      </p:sp>
      <p:sp>
        <p:nvSpPr>
          <p:cNvPr id="37" name="CuadroTexto 36">
            <a:extLst>
              <a:ext uri="{FF2B5EF4-FFF2-40B4-BE49-F238E27FC236}">
                <a16:creationId xmlns:a16="http://schemas.microsoft.com/office/drawing/2014/main" id="{A05CF313-C4EA-F466-9F64-A965EDFE680A}"/>
              </a:ext>
            </a:extLst>
          </p:cNvPr>
          <p:cNvSpPr txBox="1"/>
          <p:nvPr/>
        </p:nvSpPr>
        <p:spPr>
          <a:xfrm>
            <a:off x="1933354" y="10483518"/>
            <a:ext cx="1289537" cy="577081"/>
          </a:xfrm>
          <a:prstGeom prst="rect">
            <a:avLst/>
          </a:prstGeom>
          <a:noFill/>
        </p:spPr>
        <p:txBody>
          <a:bodyPr wrap="square" rtlCol="0" anchor="ctr" anchorCtr="1">
            <a:spAutoFit/>
          </a:bodyPr>
          <a:lstStyle/>
          <a:p>
            <a:pPr algn="ctr"/>
            <a:r>
              <a:rPr lang="es-E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gnitively</a:t>
            </a:r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impaired</a:t>
            </a:r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bjects</a:t>
            </a:r>
            <a:endParaRPr lang="es-E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es-E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s-ES" sz="1050">
                <a:latin typeface="Times New Roman" panose="02020603050405020304" pitchFamily="18" charset="0"/>
                <a:cs typeface="Times New Roman" panose="02020603050405020304" pitchFamily="18" charset="0"/>
              </a:rPr>
              <a:t>=211</a:t>
            </a:r>
            <a:endParaRPr lang="es-E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0014648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22</TotalTime>
  <Words>144</Words>
  <Application>Microsoft Macintosh PowerPoint</Application>
  <PresentationFormat>Panorámica</PresentationFormat>
  <Paragraphs>33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Fran M</dc:creator>
  <cp:lastModifiedBy>Microsoft Office User</cp:lastModifiedBy>
  <cp:revision>10</cp:revision>
  <dcterms:created xsi:type="dcterms:W3CDTF">2023-10-05T08:50:01Z</dcterms:created>
  <dcterms:modified xsi:type="dcterms:W3CDTF">2025-02-26T20:20:16Z</dcterms:modified>
</cp:coreProperties>
</file>